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4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>
            <a:extLst>
              <a:ext uri="{FF2B5EF4-FFF2-40B4-BE49-F238E27FC236}">
                <a16:creationId xmlns:a16="http://schemas.microsoft.com/office/drawing/2014/main" id="{AED0EC72-5F13-609D-31F2-A2763A3365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24204" y="3602038"/>
            <a:ext cx="10543592" cy="472329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1 Forest plot of the relationship between age and refeeding syndrome in acutely ill patients 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1F719436-B11F-A0BA-38AB-D7157E59456F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900238" y="1082352"/>
            <a:ext cx="8391525" cy="2173612"/>
            <a:chOff x="1197" y="893"/>
            <a:chExt cx="5286" cy="1158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EA5D1CFB-FA94-5813-F75F-DA2BAB9E7857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197" y="893"/>
              <a:ext cx="5286" cy="11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44E01F2C-8A2C-0063-86D1-561BF3003F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7" y="893"/>
              <a:ext cx="5286" cy="1158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3FD3B2B8-C5FF-ED15-0F47-90A510248D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97" y="1086"/>
              <a:ext cx="5286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6DFAD28D-C7A5-7350-94D9-BDE0059E88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7" y="1013"/>
              <a:ext cx="68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tudy or Sub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7FFA79CC-4130-6247-B0B9-3C12B7A19F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7" y="1120"/>
              <a:ext cx="32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ui 20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16D940C8-A487-ABF2-24D3-AE966CDE32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7" y="1215"/>
              <a:ext cx="33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ih 201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D00D92CC-96F5-31DF-4B8B-A3F11CF762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7" y="1313"/>
              <a:ext cx="28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i 201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016C6ECD-D63E-73A6-8BF4-81590A2C5E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7" y="1408"/>
              <a:ext cx="7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hariatpanahi 202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BEE96441-F318-6C2F-EB7A-D06FA5D9F8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7" y="1506"/>
              <a:ext cx="41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Zhang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52107936-D48E-CF8E-9726-F4FC1AAFBA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7" y="1690"/>
              <a:ext cx="511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 (95% CI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E97632A9-0766-E24F-B774-A6DF75D0CD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7" y="1794"/>
              <a:ext cx="19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terogeneity: Chi² = 4.56, df = 4 (P = 0.34); I² = 12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51DD2AE1-FFBE-5C97-BF46-224B362317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7" y="1892"/>
              <a:ext cx="151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est for overall effect: Z = 11.14 (P &lt; 0.00001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3524C30F-E57B-85D8-88D9-3309923D36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0" y="1013"/>
              <a:ext cx="220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ED24B584-2CBD-B64A-08CB-6543BA6A33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6" y="1120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7.1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10A289AE-F7BA-3DD3-70DE-62D0789072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6" y="1215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5.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D5003F93-34C5-0B59-E3F6-998795273D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6" y="1313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0.2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B498F21F-F2E2-33F6-03C4-BEE28535E6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6" y="1408"/>
              <a:ext cx="23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6.6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057C3704-8185-C9EF-4921-3EDF88D8AF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6" y="1506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6.7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E91C4053-B624-FD54-BA61-54C2679A4C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0" y="1013"/>
              <a:ext cx="13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72A7B297-97BD-B0C7-2CC8-CD03E3E402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6" y="1120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.1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92FE16A6-D4D5-3592-6ED9-DE8B1432B6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6" y="1215"/>
              <a:ext cx="190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.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AB6655BA-598C-585D-BF84-8D8652D49F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6" y="1313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.4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6732F533-FD3D-B1C8-6594-F0C2A8BE5A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6" y="1408"/>
              <a:ext cx="23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.2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4A4693BC-7023-44F2-29D4-D316F456E5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6" y="1506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.2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67C7F747-987B-E928-FBA4-4C9520FB2F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7" y="1013"/>
              <a:ext cx="20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ED1F56FA-9FE5-2023-2ACD-E54E87217A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5" y="1120"/>
              <a:ext cx="1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F605FEE4-EBCF-9FE7-8D9F-F1DB2D31B7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5" y="1215"/>
              <a:ext cx="12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72E10048-ECD3-3AF2-EB47-3CF94FD2E5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5" y="1313"/>
              <a:ext cx="1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579A20E8-B353-7FAF-A25C-A404F7BA55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4" y="1408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A83C6DE3-76E1-6213-7357-7696F29962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5" y="1506"/>
              <a:ext cx="1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1F7E29AB-145B-4E9A-9996-62B2B7FC02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9" y="1690"/>
              <a:ext cx="15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27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09E798F9-64E0-3517-A740-4CD62F3B0C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9" y="1013"/>
              <a:ext cx="219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38F22BDD-7CAD-6AD5-2E11-3B7B8F4012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5" y="1120"/>
              <a:ext cx="2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1.4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97CCC800-9323-4652-236E-2BDBE15444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5" y="1215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7.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92B6F11C-19F7-DA31-A9BD-DD5A4D2D90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5" y="1313"/>
              <a:ext cx="2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.8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BF60AFA4-6DB6-8157-026B-A5A27AA3FD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5" y="1408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6.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37C67901-8CD4-8774-460C-DAA10E7670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5" y="1506"/>
              <a:ext cx="2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7.3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F5B43F72-3513-4575-DF42-D6BD4962BF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9" y="1013"/>
              <a:ext cx="13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33E82F91-BAF7-1A48-922F-D52834D818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5" y="1120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.7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6C095B48-FFBA-0319-E3EE-1C3A647F18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5" y="1215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.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47156D1D-B2E1-7CE3-00F2-9BDF1FF716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5" y="1313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.7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E81F679D-BAB7-620D-627B-BB64037487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5" y="1408"/>
              <a:ext cx="23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.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97AADCCF-C2F5-9075-949E-EABB2E3AFF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5" y="1506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.4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8154421D-AD1B-FF79-2671-493508C763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1" y="1013"/>
              <a:ext cx="2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2011BD7A-397F-A9F4-72B9-92E6498667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9" y="1120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AF5F339A-335B-B430-2218-85EB9DBBB3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9" y="1215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357886B4-3E13-5D7A-52C8-6E4BB6235C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9" y="1313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AFA0E06A-D9A4-8B79-3EBD-6E96AC384E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9" y="1408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43E96442-544C-827E-BF5A-B66310BD56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9" y="1506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53">
              <a:extLst>
                <a:ext uri="{FF2B5EF4-FFF2-40B4-BE49-F238E27FC236}">
                  <a16:creationId xmlns:a16="http://schemas.microsoft.com/office/drawing/2014/main" id="{F84BF4D0-4994-AEF8-8779-FED83FB5CC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3" y="1690"/>
              <a:ext cx="15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55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91A9A6D7-C700-E1B2-9809-0B58708E72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0" y="1013"/>
              <a:ext cx="27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C2E5F2F6-5195-BF52-8909-28C3132E32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5" y="1120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2.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88E0A73A-D22B-F545-8350-9B9A821220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6" y="1215"/>
              <a:ext cx="21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6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FAED1435-FDEA-0DE2-DD9C-B284486D70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5" y="1313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.4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58">
              <a:extLst>
                <a:ext uri="{FF2B5EF4-FFF2-40B4-BE49-F238E27FC236}">
                  <a16:creationId xmlns:a16="http://schemas.microsoft.com/office/drawing/2014/main" id="{11B32EB1-AE8E-7729-D366-5EC36A0428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5" y="1408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.9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59">
              <a:extLst>
                <a:ext uri="{FF2B5EF4-FFF2-40B4-BE49-F238E27FC236}">
                  <a16:creationId xmlns:a16="http://schemas.microsoft.com/office/drawing/2014/main" id="{3919A0D0-3305-E0A4-3139-826A6647E2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5" y="1506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.1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E99DCABD-5EC0-4524-A0F1-88EF7E366A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0" y="1690"/>
              <a:ext cx="278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00.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E063242C-E5FC-272C-1D57-395E6FECC3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0" y="1013"/>
              <a:ext cx="6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Fixed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11AC5F96-C8BB-8D21-84B8-1CE636BED3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0" y="1120"/>
              <a:ext cx="55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63 [2.38, 8.88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63">
              <a:extLst>
                <a:ext uri="{FF2B5EF4-FFF2-40B4-BE49-F238E27FC236}">
                  <a16:creationId xmlns:a16="http://schemas.microsoft.com/office/drawing/2014/main" id="{85CF0B0B-2D67-B2FE-51CD-3502F0167F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9" y="1215"/>
              <a:ext cx="652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.10 [1.65, 14.55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64">
              <a:extLst>
                <a:ext uri="{FF2B5EF4-FFF2-40B4-BE49-F238E27FC236}">
                  <a16:creationId xmlns:a16="http://schemas.microsoft.com/office/drawing/2014/main" id="{E077FF7E-1816-F3E2-A1E9-8C8C486422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9" y="1313"/>
              <a:ext cx="59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.48 [4.97, 13.99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5">
              <a:extLst>
                <a:ext uri="{FF2B5EF4-FFF2-40B4-BE49-F238E27FC236}">
                  <a16:creationId xmlns:a16="http://schemas.microsoft.com/office/drawing/2014/main" id="{ED94FB33-32D2-E793-90DF-1170794FA4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9" y="1408"/>
              <a:ext cx="652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.89 [7.15, 12.63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6">
              <a:extLst>
                <a:ext uri="{FF2B5EF4-FFF2-40B4-BE49-F238E27FC236}">
                  <a16:creationId xmlns:a16="http://schemas.microsoft.com/office/drawing/2014/main" id="{FE3B8806-67B6-CB85-0134-3277ED5A8E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9" y="1506"/>
              <a:ext cx="59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.43 [6.65, 12.21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67">
              <a:extLst>
                <a:ext uri="{FF2B5EF4-FFF2-40B4-BE49-F238E27FC236}">
                  <a16:creationId xmlns:a16="http://schemas.microsoft.com/office/drawing/2014/main" id="{FBA43669-35B9-3E59-3B83-7916C6FFCE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4" y="1690"/>
              <a:ext cx="602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8.67 [7.14, 10.19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68">
              <a:extLst>
                <a:ext uri="{FF2B5EF4-FFF2-40B4-BE49-F238E27FC236}">
                  <a16:creationId xmlns:a16="http://schemas.microsoft.com/office/drawing/2014/main" id="{6C42A8BB-8243-2646-34B9-FC7AB34E69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6" y="916"/>
              <a:ext cx="447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69">
              <a:extLst>
                <a:ext uri="{FF2B5EF4-FFF2-40B4-BE49-F238E27FC236}">
                  <a16:creationId xmlns:a16="http://schemas.microsoft.com/office/drawing/2014/main" id="{5E93F316-89F5-9D0E-9707-6A6F76B166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0" y="916"/>
              <a:ext cx="621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non-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70">
              <a:extLst>
                <a:ext uri="{FF2B5EF4-FFF2-40B4-BE49-F238E27FC236}">
                  <a16:creationId xmlns:a16="http://schemas.microsoft.com/office/drawing/2014/main" id="{8DF4A831-7677-8428-FFF3-B0E97DD324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3" y="916"/>
              <a:ext cx="654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71">
              <a:extLst>
                <a:ext uri="{FF2B5EF4-FFF2-40B4-BE49-F238E27FC236}">
                  <a16:creationId xmlns:a16="http://schemas.microsoft.com/office/drawing/2014/main" id="{B9C883B6-092D-D845-D98E-4FEE341D98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6" y="916"/>
              <a:ext cx="655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72">
              <a:extLst>
                <a:ext uri="{FF2B5EF4-FFF2-40B4-BE49-F238E27FC236}">
                  <a16:creationId xmlns:a16="http://schemas.microsoft.com/office/drawing/2014/main" id="{8A570909-102E-9ED8-9EA7-AD02CA2FEC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5" y="1013"/>
              <a:ext cx="6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Fixed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Line 73">
              <a:extLst>
                <a:ext uri="{FF2B5EF4-FFF2-40B4-BE49-F238E27FC236}">
                  <a16:creationId xmlns:a16="http://schemas.microsoft.com/office/drawing/2014/main" id="{7621DEA0-2414-2EDC-3701-6EFE86FD8B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99" y="1086"/>
              <a:ext cx="0" cy="724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7" name="Line 74">
              <a:extLst>
                <a:ext uri="{FF2B5EF4-FFF2-40B4-BE49-F238E27FC236}">
                  <a16:creationId xmlns:a16="http://schemas.microsoft.com/office/drawing/2014/main" id="{8EAF1793-CA51-7EA5-217C-7A072E7D1E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10" y="1134"/>
              <a:ext cx="304" cy="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8" name="Rectangle 75">
              <a:extLst>
                <a:ext uri="{FF2B5EF4-FFF2-40B4-BE49-F238E27FC236}">
                  <a16:creationId xmlns:a16="http://schemas.microsoft.com/office/drawing/2014/main" id="{11ACB447-9D6F-B9B1-7F00-ADC5BE546F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46" y="1123"/>
              <a:ext cx="33" cy="34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9" name="Line 76">
              <a:extLst>
                <a:ext uri="{FF2B5EF4-FFF2-40B4-BE49-F238E27FC236}">
                  <a16:creationId xmlns:a16="http://schemas.microsoft.com/office/drawing/2014/main" id="{045AC9E7-9738-CF16-E7D8-492DA5B451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76" y="1231"/>
              <a:ext cx="604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0" name="Rectangle 77">
              <a:extLst>
                <a:ext uri="{FF2B5EF4-FFF2-40B4-BE49-F238E27FC236}">
                  <a16:creationId xmlns:a16="http://schemas.microsoft.com/office/drawing/2014/main" id="{1A137528-E7CF-01A1-23BC-50B74F5E9D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69" y="1228"/>
              <a:ext cx="18" cy="17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1" name="Line 78">
              <a:extLst>
                <a:ext uri="{FF2B5EF4-FFF2-40B4-BE49-F238E27FC236}">
                  <a16:creationId xmlns:a16="http://schemas.microsoft.com/office/drawing/2014/main" id="{4F032DBA-C798-ACFD-D3E0-BCED04D678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31" y="1327"/>
              <a:ext cx="423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2" name="Rectangle 79">
              <a:extLst>
                <a:ext uri="{FF2B5EF4-FFF2-40B4-BE49-F238E27FC236}">
                  <a16:creationId xmlns:a16="http://schemas.microsoft.com/office/drawing/2014/main" id="{EF8EED22-720F-6CC8-4417-A7D8349507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1" y="1322"/>
              <a:ext cx="23" cy="23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3" name="Line 80">
              <a:extLst>
                <a:ext uri="{FF2B5EF4-FFF2-40B4-BE49-F238E27FC236}">
                  <a16:creationId xmlns:a16="http://schemas.microsoft.com/office/drawing/2014/main" id="{B05817C0-77E8-640E-2728-CAC808E0A4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33" y="1424"/>
              <a:ext cx="25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4" name="Rectangle 81">
              <a:extLst>
                <a:ext uri="{FF2B5EF4-FFF2-40B4-BE49-F238E27FC236}">
                  <a16:creationId xmlns:a16="http://schemas.microsoft.com/office/drawing/2014/main" id="{EDFD04FD-CB77-6F75-EE37-DBFD6F654B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1" y="1409"/>
              <a:ext cx="41" cy="42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5" name="Line 82">
              <a:extLst>
                <a:ext uri="{FF2B5EF4-FFF2-40B4-BE49-F238E27FC236}">
                  <a16:creationId xmlns:a16="http://schemas.microsoft.com/office/drawing/2014/main" id="{58B95FB5-B0D7-D3F0-091D-AD64A7B87A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10" y="1520"/>
              <a:ext cx="260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6" name="Rectangle 83">
              <a:extLst>
                <a:ext uri="{FF2B5EF4-FFF2-40B4-BE49-F238E27FC236}">
                  <a16:creationId xmlns:a16="http://schemas.microsoft.com/office/drawing/2014/main" id="{35961E26-3D2F-C210-1808-D47D450992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0" y="1506"/>
              <a:ext cx="40" cy="41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7" name="Freeform 84">
              <a:extLst>
                <a:ext uri="{FF2B5EF4-FFF2-40B4-BE49-F238E27FC236}">
                  <a16:creationId xmlns:a16="http://schemas.microsoft.com/office/drawing/2014/main" id="{3D752EF8-8FF6-FC5D-6AEE-8820D1F8095A}"/>
                </a:ext>
              </a:extLst>
            </p:cNvPr>
            <p:cNvSpPr>
              <a:spLocks/>
            </p:cNvSpPr>
            <p:nvPr/>
          </p:nvSpPr>
          <p:spPr bwMode="auto">
            <a:xfrm>
              <a:off x="5732" y="1671"/>
              <a:ext cx="138" cy="85"/>
            </a:xfrm>
            <a:custGeom>
              <a:avLst/>
              <a:gdLst>
                <a:gd name="T0" fmla="*/ 240 w 460"/>
                <a:gd name="T1" fmla="*/ 280 h 280"/>
                <a:gd name="T2" fmla="*/ 0 w 460"/>
                <a:gd name="T3" fmla="*/ 140 h 280"/>
                <a:gd name="T4" fmla="*/ 240 w 460"/>
                <a:gd name="T5" fmla="*/ 0 h 280"/>
                <a:gd name="T6" fmla="*/ 460 w 460"/>
                <a:gd name="T7" fmla="*/ 140 h 280"/>
                <a:gd name="T8" fmla="*/ 240 w 46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60" h="280">
                  <a:moveTo>
                    <a:pt x="240" y="280"/>
                  </a:moveTo>
                  <a:lnTo>
                    <a:pt x="0" y="140"/>
                  </a:lnTo>
                  <a:lnTo>
                    <a:pt x="240" y="0"/>
                  </a:lnTo>
                  <a:lnTo>
                    <a:pt x="460" y="140"/>
                  </a:lnTo>
                  <a:lnTo>
                    <a:pt x="240" y="280"/>
                  </a:lnTo>
                  <a:close/>
                </a:path>
              </a:pathLst>
            </a:custGeom>
            <a:solidFill>
              <a:srgbClr val="000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8" name="Line 85">
              <a:extLst>
                <a:ext uri="{FF2B5EF4-FFF2-40B4-BE49-F238E27FC236}">
                  <a16:creationId xmlns:a16="http://schemas.microsoft.com/office/drawing/2014/main" id="{7BD55E89-5CA6-8641-659D-CC4EDB0963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81" y="1810"/>
              <a:ext cx="2036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9" name="Line 86">
              <a:extLst>
                <a:ext uri="{FF2B5EF4-FFF2-40B4-BE49-F238E27FC236}">
                  <a16:creationId xmlns:a16="http://schemas.microsoft.com/office/drawing/2014/main" id="{42A5EC70-A679-4849-4091-FE3888EA4C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62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0" name="Rectangle 87">
              <a:extLst>
                <a:ext uri="{FF2B5EF4-FFF2-40B4-BE49-F238E27FC236}">
                  <a16:creationId xmlns:a16="http://schemas.microsoft.com/office/drawing/2014/main" id="{29754687-7D1F-67B9-E915-C1D4B205EF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0" y="1844"/>
              <a:ext cx="1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Line 88">
              <a:extLst>
                <a:ext uri="{FF2B5EF4-FFF2-40B4-BE49-F238E27FC236}">
                  <a16:creationId xmlns:a16="http://schemas.microsoft.com/office/drawing/2014/main" id="{12540825-BCB3-8342-EC0B-46D8EB0C6F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31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2" name="Rectangle 89">
              <a:extLst>
                <a:ext uri="{FF2B5EF4-FFF2-40B4-BE49-F238E27FC236}">
                  <a16:creationId xmlns:a16="http://schemas.microsoft.com/office/drawing/2014/main" id="{EB0A5432-C651-E644-EABA-EF02F97009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9" y="1844"/>
              <a:ext cx="13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Line 90">
              <a:extLst>
                <a:ext uri="{FF2B5EF4-FFF2-40B4-BE49-F238E27FC236}">
                  <a16:creationId xmlns:a16="http://schemas.microsoft.com/office/drawing/2014/main" id="{EC266EEA-292D-0134-4656-CAE5611710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99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4" name="Rectangle 91">
              <a:extLst>
                <a:ext uri="{FF2B5EF4-FFF2-40B4-BE49-F238E27FC236}">
                  <a16:creationId xmlns:a16="http://schemas.microsoft.com/office/drawing/2014/main" id="{67C17C11-C176-F7E9-D9A0-C1CE12D7DD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9" y="1844"/>
              <a:ext cx="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Line 92">
              <a:extLst>
                <a:ext uri="{FF2B5EF4-FFF2-40B4-BE49-F238E27FC236}">
                  <a16:creationId xmlns:a16="http://schemas.microsoft.com/office/drawing/2014/main" id="{D0A79AB2-A856-D923-2CAB-269F3BD8E5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67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6" name="Rectangle 93">
              <a:extLst>
                <a:ext uri="{FF2B5EF4-FFF2-40B4-BE49-F238E27FC236}">
                  <a16:creationId xmlns:a16="http://schemas.microsoft.com/office/drawing/2014/main" id="{174868C9-51CD-7C74-7B92-771F70E041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7" y="1844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Line 94">
              <a:extLst>
                <a:ext uri="{FF2B5EF4-FFF2-40B4-BE49-F238E27FC236}">
                  <a16:creationId xmlns:a16="http://schemas.microsoft.com/office/drawing/2014/main" id="{2D5A115B-6066-B7AE-9C64-B954BEF695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35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8" name="Rectangle 95">
              <a:extLst>
                <a:ext uri="{FF2B5EF4-FFF2-40B4-BE49-F238E27FC236}">
                  <a16:creationId xmlns:a16="http://schemas.microsoft.com/office/drawing/2014/main" id="{6C8C1980-B751-4B24-D664-58F4817503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95" y="1844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96">
              <a:extLst>
                <a:ext uri="{FF2B5EF4-FFF2-40B4-BE49-F238E27FC236}">
                  <a16:creationId xmlns:a16="http://schemas.microsoft.com/office/drawing/2014/main" id="{54D10BDA-5592-CECA-D5DD-ADC3163CBD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96" y="1932"/>
              <a:ext cx="70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Rectangle 97">
              <a:extLst>
                <a:ext uri="{FF2B5EF4-FFF2-40B4-BE49-F238E27FC236}">
                  <a16:creationId xmlns:a16="http://schemas.microsoft.com/office/drawing/2014/main" id="{752ABBF6-FF98-CC7B-73A7-40DEF77C6E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29" y="1932"/>
              <a:ext cx="84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non-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59324799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6</Words>
  <Application>Microsoft Office PowerPoint</Application>
  <PresentationFormat>宽屏</PresentationFormat>
  <Paragraphs>7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吴轩乐</dc:creator>
  <cp:lastModifiedBy>轩乐 吴</cp:lastModifiedBy>
  <cp:revision>5</cp:revision>
  <dcterms:created xsi:type="dcterms:W3CDTF">2023-08-09T12:44:00Z</dcterms:created>
  <dcterms:modified xsi:type="dcterms:W3CDTF">2026-02-06T16:04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</Properties>
</file>